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6327"/>
  </p:normalViewPr>
  <p:slideViewPr>
    <p:cSldViewPr snapToGrid="0" snapToObjects="1">
      <p:cViewPr varScale="1">
        <p:scale>
          <a:sx n="104" d="100"/>
          <a:sy n="104" d="100"/>
        </p:scale>
        <p:origin x="232" y="6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288009-ACD7-144E-8F7C-D9C2A08243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03DF426-F75E-1149-825F-496C3B5CA4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BF8B03-62F1-074C-8BB5-E395F1022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8C63-0EDF-9243-838E-92AAB613784E}" type="datetimeFigureOut">
              <a:rPr kumimoji="1" lang="zh-CN" altLang="en-US" smtClean="0"/>
              <a:t>2023/1/1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33F25D8-0390-8C43-879F-C64AB3442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84FA26-3A14-CC43-8EE3-0842D73AA6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DF91-7AF8-1248-B55B-C0C3A305F8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81432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0B55A0-5720-4C48-A450-92B67F6AE3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A000F80-E780-6548-97A8-C3A46A02B8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BA7A90-FE89-1A43-8660-22F75125CE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8C63-0EDF-9243-838E-92AAB613784E}" type="datetimeFigureOut">
              <a:rPr kumimoji="1" lang="zh-CN" altLang="en-US" smtClean="0"/>
              <a:t>2023/1/1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0868D74-A9A7-EA46-BBF1-07CCDBE1B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6261FCC-13CF-8F4B-AD60-B1E7CD2C10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DF91-7AF8-1248-B55B-C0C3A305F8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92514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47D10E8-E608-6F4C-A04B-2E894AE734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24244A4-906E-2247-9BF9-05E605BCF2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5D560ED-4388-DF45-88E6-CFA34822C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8C63-0EDF-9243-838E-92AAB613784E}" type="datetimeFigureOut">
              <a:rPr kumimoji="1" lang="zh-CN" altLang="en-US" smtClean="0"/>
              <a:t>2023/1/1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2AE51F-22B1-0D44-AA45-F47FF49DA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DF4692B-A224-964C-B0F7-91C1F54D00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DF91-7AF8-1248-B55B-C0C3A305F8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97605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7EE284-3CB3-6B4C-ACC4-5304536FA7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8E8144C-36D6-4D42-8BF8-887533A054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F89E71-A9EE-324B-BA4D-BD54BB95D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8C63-0EDF-9243-838E-92AAB613784E}" type="datetimeFigureOut">
              <a:rPr kumimoji="1" lang="zh-CN" altLang="en-US" smtClean="0"/>
              <a:t>2023/1/1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F270EDD-4430-AA49-B80C-C6B5753E3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2C4E93-E17A-5541-ADE7-391CF5EEB0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DF91-7AF8-1248-B55B-C0C3A305F8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38876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782F99-6D64-C249-B1FC-DA77CC2612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671E5C8-E140-6C42-AF89-DB9A1F38AE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4A48DA-7917-5248-9B7F-AF3F780CE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8C63-0EDF-9243-838E-92AAB613784E}" type="datetimeFigureOut">
              <a:rPr kumimoji="1" lang="zh-CN" altLang="en-US" smtClean="0"/>
              <a:t>2023/1/1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B989CC9-DC0F-FA48-8A14-907B53AC0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8026D8-2A58-D443-9BB1-EE5079040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DF91-7AF8-1248-B55B-C0C3A305F8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16813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E1BD3C-61EF-2A4F-B4AE-F66302577D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6D11C68-1AEE-8341-9949-49B90AB878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7D8CD35-BF3A-704D-9AB9-7895358AE4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1D91190-E82B-8648-A241-19FDEA3AC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8C63-0EDF-9243-838E-92AAB613784E}" type="datetimeFigureOut">
              <a:rPr kumimoji="1" lang="zh-CN" altLang="en-US" smtClean="0"/>
              <a:t>2023/1/14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E769F11-E524-3549-8A35-ED1ADBB05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FB4634B-37DB-0D48-A888-1F91DBC7AA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DF91-7AF8-1248-B55B-C0C3A305F8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52541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403C63-C211-3E43-9D38-73CB600D4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0C7600-1CE7-844F-9727-884A7AB059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3A124C3-6D68-E748-99CA-7AFC3DB67A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EC52A38-EE0A-FD4D-91B9-F1796FE80E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D8BB3A9-7FA6-B64A-9931-6A15D51F05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C14C363-0291-8546-A040-04C193345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8C63-0EDF-9243-838E-92AAB613784E}" type="datetimeFigureOut">
              <a:rPr kumimoji="1" lang="zh-CN" altLang="en-US" smtClean="0"/>
              <a:t>2023/1/14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4456560-320A-4C43-BF27-4273241A5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7BB13F3-28DA-124D-9F6B-E452D9A7D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DF91-7AF8-1248-B55B-C0C3A305F8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376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767E7E-8B3A-124E-88D5-8E5718C501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AFF2FBD-1889-914E-AA09-364731262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8C63-0EDF-9243-838E-92AAB613784E}" type="datetimeFigureOut">
              <a:rPr kumimoji="1" lang="zh-CN" altLang="en-US" smtClean="0"/>
              <a:t>2023/1/14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71ECBAA-6B15-C449-80E3-4F2CFE42F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1E2F50F-F05B-A049-AF40-BE9605345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DF91-7AF8-1248-B55B-C0C3A305F8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16796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0E9AEB6-0559-DE4C-9A15-1F98524F2E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8C63-0EDF-9243-838E-92AAB613784E}" type="datetimeFigureOut">
              <a:rPr kumimoji="1" lang="zh-CN" altLang="en-US" smtClean="0"/>
              <a:t>2023/1/14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ADE5125-B04D-CC40-85CD-3DA6E0BBC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43020DD-386E-F44B-9E2E-4FC9F2969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DF91-7AF8-1248-B55B-C0C3A305F8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1843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9C3CFE-B599-8848-AD0D-213D902C59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667006E-14BC-D445-8698-50D8FF2255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4DE4AA7-09B7-694B-B214-9888EA3D24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93CFAA5-9181-094A-B863-001EB8E476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8C63-0EDF-9243-838E-92AAB613784E}" type="datetimeFigureOut">
              <a:rPr kumimoji="1" lang="zh-CN" altLang="en-US" smtClean="0"/>
              <a:t>2023/1/14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2945656-8CAE-1643-A97F-A6FB0F3024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AD7CED9-9FF7-2A43-AAFE-237A9005B5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DF91-7AF8-1248-B55B-C0C3A305F8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29413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808A868-8D44-F04E-A3DE-AC8A5818D1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0BEE0BF-3AF3-9E43-BDC7-D44AB02C15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12F2B23-0098-6D41-A7BF-753198E39E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9C732DB-0D41-E34D-8DC6-1CBD38825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D8C63-0EDF-9243-838E-92AAB613784E}" type="datetimeFigureOut">
              <a:rPr kumimoji="1" lang="zh-CN" altLang="en-US" smtClean="0"/>
              <a:t>2023/1/14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B79D387-E0D6-B74E-9975-BF3583238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C082612-B5F7-7B4D-840F-471D55238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DF91-7AF8-1248-B55B-C0C3A305F8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93720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870026B-3871-AB46-8A21-972A868EA1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314465D-DCA1-D94F-A4D9-BCFEFD6BD5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F18679-B95B-6A48-9E53-8AFC75AB0A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FD8C63-0EDF-9243-838E-92AAB613784E}" type="datetimeFigureOut">
              <a:rPr kumimoji="1" lang="zh-CN" altLang="en-US" smtClean="0"/>
              <a:t>2023/1/1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DE6648-2843-154F-ACA0-C5D11F25F3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AD2DB6-B67B-0442-9D9A-CCFDE5D905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88DF91-7AF8-1248-B55B-C0C3A305F8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06646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矩形 14">
            <a:extLst>
              <a:ext uri="{FF2B5EF4-FFF2-40B4-BE49-F238E27FC236}">
                <a16:creationId xmlns:a16="http://schemas.microsoft.com/office/drawing/2014/main" id="{249E92AD-1EE5-0148-A432-75AE0CD01BBE}"/>
              </a:ext>
            </a:extLst>
          </p:cNvPr>
          <p:cNvSpPr/>
          <p:nvPr/>
        </p:nvSpPr>
        <p:spPr>
          <a:xfrm rot="2508277">
            <a:off x="2356429" y="2652543"/>
            <a:ext cx="827155" cy="6202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dirty="0"/>
          </a:p>
        </p:txBody>
      </p:sp>
      <p:grpSp>
        <p:nvGrpSpPr>
          <p:cNvPr id="763" name="组合 762">
            <a:extLst>
              <a:ext uri="{FF2B5EF4-FFF2-40B4-BE49-F238E27FC236}">
                <a16:creationId xmlns:a16="http://schemas.microsoft.com/office/drawing/2014/main" id="{25218E76-3043-E645-891A-46DE9A038E44}"/>
              </a:ext>
            </a:extLst>
          </p:cNvPr>
          <p:cNvGrpSpPr/>
          <p:nvPr/>
        </p:nvGrpSpPr>
        <p:grpSpPr>
          <a:xfrm rot="14595071">
            <a:off x="3117929" y="3905157"/>
            <a:ext cx="1105292" cy="697505"/>
            <a:chOff x="2476341" y="601825"/>
            <a:chExt cx="1557517" cy="982886"/>
          </a:xfrm>
        </p:grpSpPr>
        <p:sp>
          <p:nvSpPr>
            <p:cNvPr id="764" name="任意形状 763">
              <a:extLst>
                <a:ext uri="{FF2B5EF4-FFF2-40B4-BE49-F238E27FC236}">
                  <a16:creationId xmlns:a16="http://schemas.microsoft.com/office/drawing/2014/main" id="{86370F7E-C594-2747-B97C-6B9F9C1B0EA7}"/>
                </a:ext>
              </a:extLst>
            </p:cNvPr>
            <p:cNvSpPr/>
            <p:nvPr/>
          </p:nvSpPr>
          <p:spPr>
            <a:xfrm>
              <a:off x="2476341" y="601825"/>
              <a:ext cx="1557517" cy="982886"/>
            </a:xfrm>
            <a:custGeom>
              <a:avLst/>
              <a:gdLst>
                <a:gd name="connsiteX0" fmla="*/ 3860 w 1557517"/>
                <a:gd name="connsiteY0" fmla="*/ 5114 h 982886"/>
                <a:gd name="connsiteX1" fmla="*/ 97075 w 1557517"/>
                <a:gd name="connsiteY1" fmla="*/ 31747 h 982886"/>
                <a:gd name="connsiteX2" fmla="*/ 221363 w 1557517"/>
                <a:gd name="connsiteY2" fmla="*/ 71696 h 982886"/>
                <a:gd name="connsiteX3" fmla="*/ 301262 w 1557517"/>
                <a:gd name="connsiteY3" fmla="*/ 98329 h 982886"/>
                <a:gd name="connsiteX4" fmla="*/ 434427 w 1557517"/>
                <a:gd name="connsiteY4" fmla="*/ 147156 h 982886"/>
                <a:gd name="connsiteX5" fmla="*/ 598664 w 1557517"/>
                <a:gd name="connsiteY5" fmla="*/ 209300 h 982886"/>
                <a:gd name="connsiteX6" fmla="*/ 785095 w 1557517"/>
                <a:gd name="connsiteY6" fmla="*/ 311393 h 982886"/>
                <a:gd name="connsiteX7" fmla="*/ 967087 w 1557517"/>
                <a:gd name="connsiteY7" fmla="*/ 444558 h 982886"/>
                <a:gd name="connsiteX8" fmla="*/ 1197906 w 1557517"/>
                <a:gd name="connsiteY8" fmla="*/ 639867 h 982886"/>
                <a:gd name="connsiteX9" fmla="*/ 1402093 w 1557517"/>
                <a:gd name="connsiteY9" fmla="*/ 830737 h 982886"/>
                <a:gd name="connsiteX10" fmla="*/ 1557452 w 1557517"/>
                <a:gd name="connsiteY10" fmla="*/ 981657 h 982886"/>
                <a:gd name="connsiteX11" fmla="*/ 1384337 w 1557517"/>
                <a:gd name="connsiteY11" fmla="*/ 906197 h 982886"/>
                <a:gd name="connsiteX12" fmla="*/ 1175712 w 1557517"/>
                <a:gd name="connsiteY12" fmla="*/ 817420 h 982886"/>
                <a:gd name="connsiteX13" fmla="*/ 878310 w 1557517"/>
                <a:gd name="connsiteY13" fmla="*/ 639867 h 982886"/>
                <a:gd name="connsiteX14" fmla="*/ 696318 w 1557517"/>
                <a:gd name="connsiteY14" fmla="*/ 502263 h 982886"/>
                <a:gd name="connsiteX15" fmla="*/ 496570 w 1557517"/>
                <a:gd name="connsiteY15" fmla="*/ 329149 h 982886"/>
                <a:gd name="connsiteX16" fmla="*/ 341211 w 1557517"/>
                <a:gd name="connsiteY16" fmla="*/ 209300 h 982886"/>
                <a:gd name="connsiteX17" fmla="*/ 230240 w 1557517"/>
                <a:gd name="connsiteY17" fmla="*/ 138279 h 982886"/>
                <a:gd name="connsiteX18" fmla="*/ 3860 w 1557517"/>
                <a:gd name="connsiteY18" fmla="*/ 5114 h 98288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557517" h="982886">
                  <a:moveTo>
                    <a:pt x="3860" y="5114"/>
                  </a:moveTo>
                  <a:cubicBezTo>
                    <a:pt x="-18334" y="-12641"/>
                    <a:pt x="60825" y="20650"/>
                    <a:pt x="97075" y="31747"/>
                  </a:cubicBezTo>
                  <a:cubicBezTo>
                    <a:pt x="133325" y="42844"/>
                    <a:pt x="221363" y="71696"/>
                    <a:pt x="221363" y="71696"/>
                  </a:cubicBezTo>
                  <a:cubicBezTo>
                    <a:pt x="255394" y="82793"/>
                    <a:pt x="265751" y="85752"/>
                    <a:pt x="301262" y="98329"/>
                  </a:cubicBezTo>
                  <a:cubicBezTo>
                    <a:pt x="336773" y="110906"/>
                    <a:pt x="434427" y="147156"/>
                    <a:pt x="434427" y="147156"/>
                  </a:cubicBezTo>
                  <a:cubicBezTo>
                    <a:pt x="483994" y="165651"/>
                    <a:pt x="540219" y="181927"/>
                    <a:pt x="598664" y="209300"/>
                  </a:cubicBezTo>
                  <a:cubicBezTo>
                    <a:pt x="657109" y="236673"/>
                    <a:pt x="723691" y="272183"/>
                    <a:pt x="785095" y="311393"/>
                  </a:cubicBezTo>
                  <a:cubicBezTo>
                    <a:pt x="846499" y="350603"/>
                    <a:pt x="898285" y="389812"/>
                    <a:pt x="967087" y="444558"/>
                  </a:cubicBezTo>
                  <a:cubicBezTo>
                    <a:pt x="1035889" y="499304"/>
                    <a:pt x="1125405" y="575504"/>
                    <a:pt x="1197906" y="639867"/>
                  </a:cubicBezTo>
                  <a:cubicBezTo>
                    <a:pt x="1270407" y="704230"/>
                    <a:pt x="1342169" y="773772"/>
                    <a:pt x="1402093" y="830737"/>
                  </a:cubicBezTo>
                  <a:cubicBezTo>
                    <a:pt x="1462017" y="887702"/>
                    <a:pt x="1560411" y="969080"/>
                    <a:pt x="1557452" y="981657"/>
                  </a:cubicBezTo>
                  <a:cubicBezTo>
                    <a:pt x="1554493" y="994234"/>
                    <a:pt x="1384337" y="906197"/>
                    <a:pt x="1384337" y="906197"/>
                  </a:cubicBezTo>
                  <a:cubicBezTo>
                    <a:pt x="1320714" y="878824"/>
                    <a:pt x="1260050" y="861808"/>
                    <a:pt x="1175712" y="817420"/>
                  </a:cubicBezTo>
                  <a:cubicBezTo>
                    <a:pt x="1091374" y="773032"/>
                    <a:pt x="958209" y="692393"/>
                    <a:pt x="878310" y="639867"/>
                  </a:cubicBezTo>
                  <a:cubicBezTo>
                    <a:pt x="798411" y="587341"/>
                    <a:pt x="759941" y="554049"/>
                    <a:pt x="696318" y="502263"/>
                  </a:cubicBezTo>
                  <a:cubicBezTo>
                    <a:pt x="632695" y="450477"/>
                    <a:pt x="555754" y="377976"/>
                    <a:pt x="496570" y="329149"/>
                  </a:cubicBezTo>
                  <a:cubicBezTo>
                    <a:pt x="437386" y="280322"/>
                    <a:pt x="385599" y="241112"/>
                    <a:pt x="341211" y="209300"/>
                  </a:cubicBezTo>
                  <a:cubicBezTo>
                    <a:pt x="296823" y="177488"/>
                    <a:pt x="284246" y="170091"/>
                    <a:pt x="230240" y="138279"/>
                  </a:cubicBezTo>
                  <a:cubicBezTo>
                    <a:pt x="176234" y="106467"/>
                    <a:pt x="26054" y="22869"/>
                    <a:pt x="3860" y="5114"/>
                  </a:cubicBezTo>
                  <a:close/>
                </a:path>
              </a:pathLst>
            </a:custGeom>
            <a:solidFill>
              <a:srgbClr val="B9B9B8"/>
            </a:solidFill>
            <a:ln w="12700">
              <a:solidFill>
                <a:srgbClr val="6F707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dirty="0"/>
            </a:p>
          </p:txBody>
        </p:sp>
        <p:sp>
          <p:nvSpPr>
            <p:cNvPr id="765" name="椭圆 764">
              <a:extLst>
                <a:ext uri="{FF2B5EF4-FFF2-40B4-BE49-F238E27FC236}">
                  <a16:creationId xmlns:a16="http://schemas.microsoft.com/office/drawing/2014/main" id="{3DF5696D-D548-794E-9ABE-F75328EC499D}"/>
                </a:ext>
              </a:extLst>
            </p:cNvPr>
            <p:cNvSpPr/>
            <p:nvPr/>
          </p:nvSpPr>
          <p:spPr>
            <a:xfrm rot="2084698">
              <a:off x="3169251" y="1050960"/>
              <a:ext cx="355795" cy="84616"/>
            </a:xfrm>
            <a:prstGeom prst="ellipse">
              <a:avLst/>
            </a:prstGeom>
            <a:solidFill>
              <a:srgbClr val="6F7071"/>
            </a:solidFill>
            <a:ln w="254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dirty="0"/>
            </a:p>
          </p:txBody>
        </p:sp>
      </p:grpSp>
      <p:grpSp>
        <p:nvGrpSpPr>
          <p:cNvPr id="801" name="组合 800">
            <a:extLst>
              <a:ext uri="{FF2B5EF4-FFF2-40B4-BE49-F238E27FC236}">
                <a16:creationId xmlns:a16="http://schemas.microsoft.com/office/drawing/2014/main" id="{4BAE694D-808F-5948-9F37-CF21006E51D7}"/>
              </a:ext>
            </a:extLst>
          </p:cNvPr>
          <p:cNvGrpSpPr/>
          <p:nvPr/>
        </p:nvGrpSpPr>
        <p:grpSpPr>
          <a:xfrm>
            <a:off x="468603" y="1986104"/>
            <a:ext cx="3117681" cy="3099342"/>
            <a:chOff x="643282" y="1708834"/>
            <a:chExt cx="3460689" cy="3440332"/>
          </a:xfrm>
        </p:grpSpPr>
        <p:pic>
          <p:nvPicPr>
            <p:cNvPr id="802" name="图片 801">
              <a:extLst>
                <a:ext uri="{FF2B5EF4-FFF2-40B4-BE49-F238E27FC236}">
                  <a16:creationId xmlns:a16="http://schemas.microsoft.com/office/drawing/2014/main" id="{C9F8BA17-4E89-F145-82F3-2F983789D29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3282" y="1708834"/>
              <a:ext cx="3460689" cy="3440332"/>
            </a:xfrm>
            <a:prstGeom prst="rect">
              <a:avLst/>
            </a:prstGeom>
          </p:spPr>
        </p:pic>
        <p:sp>
          <p:nvSpPr>
            <p:cNvPr id="803" name="矩形 802">
              <a:extLst>
                <a:ext uri="{FF2B5EF4-FFF2-40B4-BE49-F238E27FC236}">
                  <a16:creationId xmlns:a16="http://schemas.microsoft.com/office/drawing/2014/main" id="{3CE81EC3-2C29-944D-9B34-F6E7AD683F2B}"/>
                </a:ext>
              </a:extLst>
            </p:cNvPr>
            <p:cNvSpPr/>
            <p:nvPr/>
          </p:nvSpPr>
          <p:spPr>
            <a:xfrm rot="2508277">
              <a:off x="2470430" y="3243795"/>
              <a:ext cx="618052" cy="4634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dirty="0"/>
            </a:p>
          </p:txBody>
        </p:sp>
      </p:grpSp>
      <p:pic>
        <p:nvPicPr>
          <p:cNvPr id="800" name="图片 799" descr="图片包含 游戏机&#10;&#10;描述已自动生成">
            <a:extLst>
              <a:ext uri="{FF2B5EF4-FFF2-40B4-BE49-F238E27FC236}">
                <a16:creationId xmlns:a16="http://schemas.microsoft.com/office/drawing/2014/main" id="{9402C958-1CB0-164A-8CB5-F09DD50CF7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3138840" y="3307234"/>
            <a:ext cx="2916151" cy="2754783"/>
          </a:xfrm>
          <a:prstGeom prst="rect">
            <a:avLst/>
          </a:prstGeom>
        </p:spPr>
      </p:pic>
      <p:cxnSp>
        <p:nvCxnSpPr>
          <p:cNvPr id="805" name="直线连接符 804">
            <a:extLst>
              <a:ext uri="{FF2B5EF4-FFF2-40B4-BE49-F238E27FC236}">
                <a16:creationId xmlns:a16="http://schemas.microsoft.com/office/drawing/2014/main" id="{6CE6DD86-5C5A-8F42-A1DA-1DDF9B8CB8F9}"/>
              </a:ext>
            </a:extLst>
          </p:cNvPr>
          <p:cNvCxnSpPr/>
          <p:nvPr/>
        </p:nvCxnSpPr>
        <p:spPr>
          <a:xfrm>
            <a:off x="2134874" y="2962675"/>
            <a:ext cx="2433609" cy="506867"/>
          </a:xfrm>
          <a:prstGeom prst="line">
            <a:avLst/>
          </a:prstGeom>
          <a:ln w="12700" cap="rnd">
            <a:solidFill>
              <a:schemeClr val="accent3"/>
            </a:solidFill>
            <a:round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1" name="直线连接符 810">
            <a:extLst>
              <a:ext uri="{FF2B5EF4-FFF2-40B4-BE49-F238E27FC236}">
                <a16:creationId xmlns:a16="http://schemas.microsoft.com/office/drawing/2014/main" id="{3CA7B2A7-CA6A-1D48-9DE2-EF5FC95FA71E}"/>
              </a:ext>
            </a:extLst>
          </p:cNvPr>
          <p:cNvCxnSpPr>
            <a:cxnSpLocks/>
          </p:cNvCxnSpPr>
          <p:nvPr/>
        </p:nvCxnSpPr>
        <p:spPr>
          <a:xfrm>
            <a:off x="2025381" y="3517521"/>
            <a:ext cx="1468197" cy="1821355"/>
          </a:xfrm>
          <a:prstGeom prst="line">
            <a:avLst/>
          </a:prstGeom>
          <a:ln w="12700" cap="rnd">
            <a:solidFill>
              <a:schemeClr val="accent3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15" name="图片 814">
            <a:extLst>
              <a:ext uri="{FF2B5EF4-FFF2-40B4-BE49-F238E27FC236}">
                <a16:creationId xmlns:a16="http://schemas.microsoft.com/office/drawing/2014/main" id="{22B4DD96-2CD5-7E46-B485-8EA35EDF383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9242" t="17073" r="46733" b="41430"/>
          <a:stretch/>
        </p:blipFill>
        <p:spPr>
          <a:xfrm>
            <a:off x="4916289" y="1611915"/>
            <a:ext cx="864000" cy="784421"/>
          </a:xfrm>
          <a:prstGeom prst="rect">
            <a:avLst/>
          </a:prstGeom>
        </p:spPr>
      </p:pic>
      <p:pic>
        <p:nvPicPr>
          <p:cNvPr id="816" name="图片 815">
            <a:extLst>
              <a:ext uri="{FF2B5EF4-FFF2-40B4-BE49-F238E27FC236}">
                <a16:creationId xmlns:a16="http://schemas.microsoft.com/office/drawing/2014/main" id="{C07CDCF2-8C5C-9D41-A0D1-5DB175F73D7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5711" t="16388" b="39108"/>
          <a:stretch/>
        </p:blipFill>
        <p:spPr>
          <a:xfrm>
            <a:off x="5619874" y="2568616"/>
            <a:ext cx="897082" cy="864000"/>
          </a:xfrm>
          <a:prstGeom prst="rect">
            <a:avLst/>
          </a:prstGeom>
        </p:spPr>
      </p:pic>
      <p:pic>
        <p:nvPicPr>
          <p:cNvPr id="817" name="图片 816">
            <a:extLst>
              <a:ext uri="{FF2B5EF4-FFF2-40B4-BE49-F238E27FC236}">
                <a16:creationId xmlns:a16="http://schemas.microsoft.com/office/drawing/2014/main" id="{52C98412-42BA-B94D-B5F7-31E19BAD543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3899" t="16622" r="23972" b="40679"/>
          <a:stretch/>
        </p:blipFill>
        <p:spPr>
          <a:xfrm>
            <a:off x="6370624" y="1560475"/>
            <a:ext cx="864000" cy="876343"/>
          </a:xfrm>
          <a:prstGeom prst="rect">
            <a:avLst/>
          </a:prstGeom>
        </p:spPr>
      </p:pic>
      <p:pic>
        <p:nvPicPr>
          <p:cNvPr id="819" name="图片 818" descr="形状&#10;&#10;中度可信度描述已自动生成">
            <a:extLst>
              <a:ext uri="{FF2B5EF4-FFF2-40B4-BE49-F238E27FC236}">
                <a16:creationId xmlns:a16="http://schemas.microsoft.com/office/drawing/2014/main" id="{1AA9E88C-EB90-C345-8C7F-E70826DB1E6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031" t="20316" r="75711" b="49755"/>
          <a:stretch/>
        </p:blipFill>
        <p:spPr>
          <a:xfrm>
            <a:off x="4494272" y="4918492"/>
            <a:ext cx="290118" cy="214702"/>
          </a:xfrm>
          <a:prstGeom prst="rect">
            <a:avLst/>
          </a:prstGeom>
        </p:spPr>
      </p:pic>
      <p:pic>
        <p:nvPicPr>
          <p:cNvPr id="820" name="图片 819" descr="形状&#10;&#10;中度可信度描述已自动生成">
            <a:extLst>
              <a:ext uri="{FF2B5EF4-FFF2-40B4-BE49-F238E27FC236}">
                <a16:creationId xmlns:a16="http://schemas.microsoft.com/office/drawing/2014/main" id="{822E66C2-8A14-874D-8D65-BED28BE2492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031" t="20316" r="75711" b="49755"/>
          <a:stretch/>
        </p:blipFill>
        <p:spPr>
          <a:xfrm>
            <a:off x="4584353" y="4616470"/>
            <a:ext cx="290119" cy="214703"/>
          </a:xfrm>
          <a:prstGeom prst="rect">
            <a:avLst/>
          </a:prstGeom>
        </p:spPr>
      </p:pic>
      <p:pic>
        <p:nvPicPr>
          <p:cNvPr id="821" name="图片 820" descr="形状&#10;&#10;中度可信度描述已自动生成">
            <a:extLst>
              <a:ext uri="{FF2B5EF4-FFF2-40B4-BE49-F238E27FC236}">
                <a16:creationId xmlns:a16="http://schemas.microsoft.com/office/drawing/2014/main" id="{CC686DB4-2F3B-944B-A013-F05F5C3C49B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031" t="20316" r="75711" b="49755"/>
          <a:stretch/>
        </p:blipFill>
        <p:spPr>
          <a:xfrm>
            <a:off x="4603734" y="4401627"/>
            <a:ext cx="260045" cy="192446"/>
          </a:xfrm>
          <a:prstGeom prst="rect">
            <a:avLst/>
          </a:prstGeom>
        </p:spPr>
      </p:pic>
      <p:pic>
        <p:nvPicPr>
          <p:cNvPr id="822" name="图片 821" descr="形状&#10;&#10;中度可信度描述已自动生成">
            <a:extLst>
              <a:ext uri="{FF2B5EF4-FFF2-40B4-BE49-F238E27FC236}">
                <a16:creationId xmlns:a16="http://schemas.microsoft.com/office/drawing/2014/main" id="{57F5CE79-6456-F94A-A0F4-3908595F781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031" t="20316" r="75711" b="49755"/>
          <a:stretch/>
        </p:blipFill>
        <p:spPr>
          <a:xfrm>
            <a:off x="4139876" y="4681499"/>
            <a:ext cx="290118" cy="214702"/>
          </a:xfrm>
          <a:prstGeom prst="rect">
            <a:avLst/>
          </a:prstGeom>
        </p:spPr>
      </p:pic>
      <p:pic>
        <p:nvPicPr>
          <p:cNvPr id="823" name="图片 822" descr="形状&#10;&#10;中度可信度描述已自动生成">
            <a:extLst>
              <a:ext uri="{FF2B5EF4-FFF2-40B4-BE49-F238E27FC236}">
                <a16:creationId xmlns:a16="http://schemas.microsoft.com/office/drawing/2014/main" id="{1FA25D90-FBF5-FD41-8F11-3942DF2EBA2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031" t="20316" r="75711" b="49755"/>
          <a:stretch/>
        </p:blipFill>
        <p:spPr>
          <a:xfrm>
            <a:off x="4249115" y="4443726"/>
            <a:ext cx="290118" cy="214702"/>
          </a:xfrm>
          <a:prstGeom prst="rect">
            <a:avLst/>
          </a:prstGeom>
        </p:spPr>
      </p:pic>
      <p:pic>
        <p:nvPicPr>
          <p:cNvPr id="824" name="图片 823">
            <a:extLst>
              <a:ext uri="{FF2B5EF4-FFF2-40B4-BE49-F238E27FC236}">
                <a16:creationId xmlns:a16="http://schemas.microsoft.com/office/drawing/2014/main" id="{3A8680A0-6E70-F740-89A2-D4A4480A929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6632" t="21000" r="27360" b="50413"/>
          <a:stretch/>
        </p:blipFill>
        <p:spPr>
          <a:xfrm>
            <a:off x="4271993" y="4926881"/>
            <a:ext cx="168908" cy="158565"/>
          </a:xfrm>
          <a:prstGeom prst="rect">
            <a:avLst/>
          </a:prstGeom>
        </p:spPr>
      </p:pic>
      <p:pic>
        <p:nvPicPr>
          <p:cNvPr id="825" name="图片 824">
            <a:extLst>
              <a:ext uri="{FF2B5EF4-FFF2-40B4-BE49-F238E27FC236}">
                <a16:creationId xmlns:a16="http://schemas.microsoft.com/office/drawing/2014/main" id="{8C064955-A84F-074E-9606-C131F0C4AF8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6632" t="21000" r="27360" b="50413"/>
          <a:stretch/>
        </p:blipFill>
        <p:spPr>
          <a:xfrm>
            <a:off x="4455904" y="4293700"/>
            <a:ext cx="166657" cy="156452"/>
          </a:xfrm>
          <a:prstGeom prst="rect">
            <a:avLst/>
          </a:prstGeom>
        </p:spPr>
      </p:pic>
      <p:pic>
        <p:nvPicPr>
          <p:cNvPr id="826" name="图片 825">
            <a:extLst>
              <a:ext uri="{FF2B5EF4-FFF2-40B4-BE49-F238E27FC236}">
                <a16:creationId xmlns:a16="http://schemas.microsoft.com/office/drawing/2014/main" id="{F2FA5A15-B2E2-8E43-A610-2547A74F04F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0151" t="19468" r="3908" b="50155"/>
          <a:stretch/>
        </p:blipFill>
        <p:spPr>
          <a:xfrm>
            <a:off x="4432997" y="4780461"/>
            <a:ext cx="146176" cy="146420"/>
          </a:xfrm>
          <a:prstGeom prst="rect">
            <a:avLst/>
          </a:prstGeom>
        </p:spPr>
      </p:pic>
      <p:pic>
        <p:nvPicPr>
          <p:cNvPr id="828" name="图片 827">
            <a:extLst>
              <a:ext uri="{FF2B5EF4-FFF2-40B4-BE49-F238E27FC236}">
                <a16:creationId xmlns:a16="http://schemas.microsoft.com/office/drawing/2014/main" id="{7C8A324B-320F-C049-B5D8-761E06CC828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0151" t="19468" r="3908" b="50155"/>
          <a:stretch/>
        </p:blipFill>
        <p:spPr>
          <a:xfrm>
            <a:off x="4803952" y="4831173"/>
            <a:ext cx="146176" cy="146420"/>
          </a:xfrm>
          <a:prstGeom prst="rect">
            <a:avLst/>
          </a:prstGeom>
        </p:spPr>
      </p:pic>
      <p:pic>
        <p:nvPicPr>
          <p:cNvPr id="830" name="图片 829" descr="图片包含 图表&#10;&#10;描述已自动生成">
            <a:extLst>
              <a:ext uri="{FF2B5EF4-FFF2-40B4-BE49-F238E27FC236}">
                <a16:creationId xmlns:a16="http://schemas.microsoft.com/office/drawing/2014/main" id="{E3B8674E-385D-524F-B0D7-8110DC8AFD9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9432" t="12333" r="22307" b="13368"/>
          <a:stretch/>
        </p:blipFill>
        <p:spPr>
          <a:xfrm>
            <a:off x="7100646" y="3429000"/>
            <a:ext cx="4288352" cy="3075666"/>
          </a:xfrm>
          <a:prstGeom prst="rect">
            <a:avLst/>
          </a:prstGeom>
        </p:spPr>
      </p:pic>
      <p:sp>
        <p:nvSpPr>
          <p:cNvPr id="831" name="矩形 830">
            <a:extLst>
              <a:ext uri="{FF2B5EF4-FFF2-40B4-BE49-F238E27FC236}">
                <a16:creationId xmlns:a16="http://schemas.microsoft.com/office/drawing/2014/main" id="{DA82040A-ADB5-A049-B35E-F8E7FE7E0133}"/>
              </a:ext>
            </a:extLst>
          </p:cNvPr>
          <p:cNvSpPr/>
          <p:nvPr/>
        </p:nvSpPr>
        <p:spPr>
          <a:xfrm>
            <a:off x="7792839" y="2216133"/>
            <a:ext cx="4288353" cy="87203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kern="1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ystemic immune inflammation index</a:t>
            </a:r>
            <a:endParaRPr lang="en-US" altLang="zh-CN" b="1" kern="100" dirty="0">
              <a:solidFill>
                <a:srgbClr val="000000"/>
              </a:solidFill>
              <a:effectLst/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altLang="zh-CN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II</a:t>
            </a:r>
            <a:r>
              <a:rPr lang="zh-CN" altLang="zh-CN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2" name="文本框 831">
            <a:extLst>
              <a:ext uri="{FF2B5EF4-FFF2-40B4-BE49-F238E27FC236}">
                <a16:creationId xmlns:a16="http://schemas.microsoft.com/office/drawing/2014/main" id="{73218741-F022-AE4C-A919-3B85ED09411E}"/>
              </a:ext>
            </a:extLst>
          </p:cNvPr>
          <p:cNvSpPr txBox="1"/>
          <p:nvPr/>
        </p:nvSpPr>
        <p:spPr>
          <a:xfrm>
            <a:off x="5872868" y="1703062"/>
            <a:ext cx="4051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×</a:t>
            </a:r>
            <a:endParaRPr kumimoji="1" lang="zh-CN" altLang="en-US" sz="2400" dirty="0"/>
          </a:p>
        </p:txBody>
      </p:sp>
      <p:cxnSp>
        <p:nvCxnSpPr>
          <p:cNvPr id="834" name="直线连接符 833">
            <a:extLst>
              <a:ext uri="{FF2B5EF4-FFF2-40B4-BE49-F238E27FC236}">
                <a16:creationId xmlns:a16="http://schemas.microsoft.com/office/drawing/2014/main" id="{36F1AA8A-A76A-AF43-8BAC-B5BB32E666E9}"/>
              </a:ext>
            </a:extLst>
          </p:cNvPr>
          <p:cNvCxnSpPr>
            <a:cxnSpLocks/>
          </p:cNvCxnSpPr>
          <p:nvPr/>
        </p:nvCxnSpPr>
        <p:spPr>
          <a:xfrm>
            <a:off x="4743644" y="2516501"/>
            <a:ext cx="25885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7" name="文本框 836">
            <a:extLst>
              <a:ext uri="{FF2B5EF4-FFF2-40B4-BE49-F238E27FC236}">
                <a16:creationId xmlns:a16="http://schemas.microsoft.com/office/drawing/2014/main" id="{01316A98-8FD1-B34E-A793-FF36621A49E3}"/>
              </a:ext>
            </a:extLst>
          </p:cNvPr>
          <p:cNvSpPr txBox="1"/>
          <p:nvPr/>
        </p:nvSpPr>
        <p:spPr>
          <a:xfrm>
            <a:off x="7429121" y="2285668"/>
            <a:ext cx="3741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F972F55-3E3A-8A4C-9827-89DEE34D1ECF}"/>
              </a:ext>
            </a:extLst>
          </p:cNvPr>
          <p:cNvSpPr txBox="1"/>
          <p:nvPr/>
        </p:nvSpPr>
        <p:spPr>
          <a:xfrm>
            <a:off x="1057266" y="136035"/>
            <a:ext cx="10077467" cy="958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Do postoperative inflammatory biomarkers impact the prediction of aorta-related adverse events (AAEs) after TEVAR for type B aortic dissection?</a:t>
            </a:r>
          </a:p>
        </p:txBody>
      </p:sp>
    </p:spTree>
    <p:extLst>
      <p:ext uri="{BB962C8B-B14F-4D97-AF65-F5344CB8AC3E}">
        <p14:creationId xmlns:p14="http://schemas.microsoft.com/office/powerpoint/2010/main" val="188040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Macintosh PowerPoint</Application>
  <PresentationFormat>宽屏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subject/>
  <dc:creator>赵 雨菲</dc:creator>
  <cp:keywords/>
  <dc:description/>
  <cp:lastModifiedBy>赵 雨菲</cp:lastModifiedBy>
  <cp:revision>1</cp:revision>
  <dcterms:created xsi:type="dcterms:W3CDTF">2023-01-13T17:06:06Z</dcterms:created>
  <dcterms:modified xsi:type="dcterms:W3CDTF">2023-01-13T17:06:51Z</dcterms:modified>
  <cp:category/>
</cp:coreProperties>
</file>